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13716000" cy="6400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2EC299A-B905-4A45-9BC2-06D64E72570F}" v="1" dt="2021-12-10T21:30:19.49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25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med Hooshangnejad" userId="1d4484e6-d156-41e7-adc6-6060c7474042" providerId="ADAL" clId="{32EC299A-B905-4A45-9BC2-06D64E72570F}"/>
    <pc:docChg chg="modSld">
      <pc:chgData name="Hamed Hooshangnejad" userId="1d4484e6-d156-41e7-adc6-6060c7474042" providerId="ADAL" clId="{32EC299A-B905-4A45-9BC2-06D64E72570F}" dt="2021-12-10T21:30:19.492" v="0" actId="14826"/>
      <pc:docMkLst>
        <pc:docMk/>
      </pc:docMkLst>
      <pc:sldChg chg="modSp">
        <pc:chgData name="Hamed Hooshangnejad" userId="1d4484e6-d156-41e7-adc6-6060c7474042" providerId="ADAL" clId="{32EC299A-B905-4A45-9BC2-06D64E72570F}" dt="2021-12-10T21:30:19.492" v="0" actId="14826"/>
        <pc:sldMkLst>
          <pc:docMk/>
          <pc:sldMk cId="2181576464" sldId="256"/>
        </pc:sldMkLst>
        <pc:picChg chg="mod">
          <ac:chgData name="Hamed Hooshangnejad" userId="1d4484e6-d156-41e7-adc6-6060c7474042" providerId="ADAL" clId="{32EC299A-B905-4A45-9BC2-06D64E72570F}" dt="2021-12-10T21:30:19.492" v="0" actId="14826"/>
          <ac:picMkLst>
            <pc:docMk/>
            <pc:sldMk cId="2181576464" sldId="256"/>
            <ac:picMk id="53" creationId="{A6894C74-1CCA-46F2-ADB2-BB2E9274CABE}"/>
          </ac:picMkLst>
        </pc:picChg>
      </pc:sldChg>
    </pc:docChg>
  </pc:docChgLst>
  <pc:docChgLst>
    <pc:chgData name="Hamed Hooshangnejad" userId="1d4484e6-d156-41e7-adc6-6060c7474042" providerId="ADAL" clId="{4A086E61-927A-47D1-8E25-811AB0B3FED6}"/>
    <pc:docChg chg="undo custSel addSld delSld modSld">
      <pc:chgData name="Hamed Hooshangnejad" userId="1d4484e6-d156-41e7-adc6-6060c7474042" providerId="ADAL" clId="{4A086E61-927A-47D1-8E25-811AB0B3FED6}" dt="2021-10-15T20:34:53.832" v="251" actId="1076"/>
      <pc:docMkLst>
        <pc:docMk/>
      </pc:docMkLst>
      <pc:sldChg chg="addSp delSp modSp new mod modAnim">
        <pc:chgData name="Hamed Hooshangnejad" userId="1d4484e6-d156-41e7-adc6-6060c7474042" providerId="ADAL" clId="{4A086E61-927A-47D1-8E25-811AB0B3FED6}" dt="2021-10-15T20:34:53.832" v="251" actId="1076"/>
        <pc:sldMkLst>
          <pc:docMk/>
          <pc:sldMk cId="2181576464" sldId="256"/>
        </pc:sldMkLst>
        <pc:spChg chg="del">
          <ac:chgData name="Hamed Hooshangnejad" userId="1d4484e6-d156-41e7-adc6-6060c7474042" providerId="ADAL" clId="{4A086E61-927A-47D1-8E25-811AB0B3FED6}" dt="2021-10-15T19:41:57.401" v="1" actId="478"/>
          <ac:spMkLst>
            <pc:docMk/>
            <pc:sldMk cId="2181576464" sldId="256"/>
            <ac:spMk id="2" creationId="{2E64102A-1059-402F-884A-42AAA51597D4}"/>
          </ac:spMkLst>
        </pc:spChg>
        <pc:spChg chg="del">
          <ac:chgData name="Hamed Hooshangnejad" userId="1d4484e6-d156-41e7-adc6-6060c7474042" providerId="ADAL" clId="{4A086E61-927A-47D1-8E25-811AB0B3FED6}" dt="2021-10-15T19:41:57.401" v="1" actId="478"/>
          <ac:spMkLst>
            <pc:docMk/>
            <pc:sldMk cId="2181576464" sldId="256"/>
            <ac:spMk id="3" creationId="{84E6E247-CADB-42DD-99B8-4993D91EA1B7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4" creationId="{D0E4DAE5-7543-4E03-A1FD-464DBD06C807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6" creationId="{9353A29B-AA7D-4BF3-9037-C9CDAB7EF4E9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7" creationId="{765A513B-EB51-4003-920E-85792614BF7E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8" creationId="{A38D5EDC-AD6D-4784-94FC-C10951E3F795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10" creationId="{C6B1B3B4-CFA7-4A56-9591-F33EE3701AF3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11" creationId="{E817BA4B-1272-42F0-BDE1-4632A26144B5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12" creationId="{45D47E89-3C7D-49AD-8A5D-2BB32C2107F8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13" creationId="{5C9B4FF2-681C-449A-B36B-3DA631D90CD5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15" creationId="{4C85D1E5-5E42-4C37-AD89-C342D2E1DE9C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16" creationId="{3D101C30-0CD9-4471-9358-E6B582795601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18" creationId="{77AEB373-037D-496F-BF3F-75B0FBA34472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21" creationId="{01F30F68-370F-4226-B8E8-C4DC1FDB3AB6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23" creationId="{9F24B9C5-B2D1-4EA0-BCED-0D7F0EED024A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27" creationId="{07F39CDF-BD57-40D6-AA5E-00D3A73B0947}"/>
          </ac:spMkLst>
        </pc:spChg>
        <pc:spChg chg="mod">
          <ac:chgData name="Hamed Hooshangnejad" userId="1d4484e6-d156-41e7-adc6-6060c7474042" providerId="ADAL" clId="{4A086E61-927A-47D1-8E25-811AB0B3FED6}" dt="2021-10-15T20:05:37.580" v="5" actId="948"/>
          <ac:spMkLst>
            <pc:docMk/>
            <pc:sldMk cId="2181576464" sldId="256"/>
            <ac:spMk id="29" creationId="{F3C22160-AC27-4778-AFFD-DA0FBEC73CC7}"/>
          </ac:spMkLst>
        </pc:spChg>
        <pc:spChg chg="mod">
          <ac:chgData name="Hamed Hooshangnejad" userId="1d4484e6-d156-41e7-adc6-6060c7474042" providerId="ADAL" clId="{4A086E61-927A-47D1-8E25-811AB0B3FED6}" dt="2021-10-15T20:05:38.769" v="6" actId="948"/>
          <ac:spMkLst>
            <pc:docMk/>
            <pc:sldMk cId="2181576464" sldId="256"/>
            <ac:spMk id="30" creationId="{DA21C477-96F4-47E7-AD5A-03192B4CE3F6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31" creationId="{54AF9237-87FC-48F8-BED2-0DF6D682C0D5}"/>
          </ac:spMkLst>
        </pc:spChg>
        <pc:spChg chg="mod">
          <ac:chgData name="Hamed Hooshangnejad" userId="1d4484e6-d156-41e7-adc6-6060c7474042" providerId="ADAL" clId="{4A086E61-927A-47D1-8E25-811AB0B3FED6}" dt="2021-10-15T20:05:37.580" v="5" actId="948"/>
          <ac:spMkLst>
            <pc:docMk/>
            <pc:sldMk cId="2181576464" sldId="256"/>
            <ac:spMk id="35" creationId="{B23451AA-81AA-420B-89BD-6AE0EB0B5473}"/>
          </ac:spMkLst>
        </pc:spChg>
        <pc:spChg chg="mod">
          <ac:chgData name="Hamed Hooshangnejad" userId="1d4484e6-d156-41e7-adc6-6060c7474042" providerId="ADAL" clId="{4A086E61-927A-47D1-8E25-811AB0B3FED6}" dt="2021-10-15T20:05:37.580" v="5" actId="948"/>
          <ac:spMkLst>
            <pc:docMk/>
            <pc:sldMk cId="2181576464" sldId="256"/>
            <ac:spMk id="36" creationId="{A6970436-43B0-4190-928E-152553021A5F}"/>
          </ac:spMkLst>
        </pc:spChg>
        <pc:spChg chg="mod">
          <ac:chgData name="Hamed Hooshangnejad" userId="1d4484e6-d156-41e7-adc6-6060c7474042" providerId="ADAL" clId="{4A086E61-927A-47D1-8E25-811AB0B3FED6}" dt="2021-10-15T20:05:37.580" v="5" actId="948"/>
          <ac:spMkLst>
            <pc:docMk/>
            <pc:sldMk cId="2181576464" sldId="256"/>
            <ac:spMk id="37" creationId="{1F4F6466-E671-49AB-BBD3-03D36A6850F4}"/>
          </ac:spMkLst>
        </pc:spChg>
        <pc:spChg chg="mod">
          <ac:chgData name="Hamed Hooshangnejad" userId="1d4484e6-d156-41e7-adc6-6060c7474042" providerId="ADAL" clId="{4A086E61-927A-47D1-8E25-811AB0B3FED6}" dt="2021-10-15T20:05:37.580" v="5" actId="948"/>
          <ac:spMkLst>
            <pc:docMk/>
            <pc:sldMk cId="2181576464" sldId="256"/>
            <ac:spMk id="39" creationId="{23BB4485-2CF9-4482-BC23-ACC682A04C27}"/>
          </ac:spMkLst>
        </pc:spChg>
        <pc:spChg chg="mod">
          <ac:chgData name="Hamed Hooshangnejad" userId="1d4484e6-d156-41e7-adc6-6060c7474042" providerId="ADAL" clId="{4A086E61-927A-47D1-8E25-811AB0B3FED6}" dt="2021-10-15T20:05:37.580" v="5" actId="948"/>
          <ac:spMkLst>
            <pc:docMk/>
            <pc:sldMk cId="2181576464" sldId="256"/>
            <ac:spMk id="40" creationId="{FF5847E8-9434-4040-A830-EF4A961F53DD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43" creationId="{B00F24C8-401E-4FA1-A419-CB897C73C610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44" creationId="{AA051EFE-FABE-471E-A9D8-F7EA23717A48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47" creationId="{DEDDE289-845A-4CA5-BE46-4FF0A2ED4EC1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48" creationId="{A1CDFAD1-FDD3-4C1C-A31C-642174AEF682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50" creationId="{67AEAC82-50C7-463D-8D39-1FE0475BE1BA}"/>
          </ac:spMkLst>
        </pc:spChg>
        <pc:spChg chg="add del mod">
          <ac:chgData name="Hamed Hooshangnejad" userId="1d4484e6-d156-41e7-adc6-6060c7474042" providerId="ADAL" clId="{4A086E61-927A-47D1-8E25-811AB0B3FED6}" dt="2021-10-15T20:05:40.204" v="7"/>
          <ac:spMkLst>
            <pc:docMk/>
            <pc:sldMk cId="2181576464" sldId="256"/>
            <ac:spMk id="52" creationId="{20BD678A-69FF-4DF6-9691-58B9A24603D4}"/>
          </ac:spMkLst>
        </pc:spChg>
        <pc:spChg chg="add mod">
          <ac:chgData name="Hamed Hooshangnejad" userId="1d4484e6-d156-41e7-adc6-6060c7474042" providerId="ADAL" clId="{4A086E61-927A-47D1-8E25-811AB0B3FED6}" dt="2021-10-15T20:09:14.812" v="127" actId="1037"/>
          <ac:spMkLst>
            <pc:docMk/>
            <pc:sldMk cId="2181576464" sldId="256"/>
            <ac:spMk id="54" creationId="{34CE3F19-A4B5-41ED-9592-33C42EC42791}"/>
          </ac:spMkLst>
        </pc:spChg>
        <pc:spChg chg="add mod">
          <ac:chgData name="Hamed Hooshangnejad" userId="1d4484e6-d156-41e7-adc6-6060c7474042" providerId="ADAL" clId="{4A086E61-927A-47D1-8E25-811AB0B3FED6}" dt="2021-10-15T20:16:49.816" v="176" actId="20577"/>
          <ac:spMkLst>
            <pc:docMk/>
            <pc:sldMk cId="2181576464" sldId="256"/>
            <ac:spMk id="55" creationId="{3D7A2111-C171-4795-AAE4-B2C5FF3EF224}"/>
          </ac:spMkLst>
        </pc:spChg>
        <pc:spChg chg="add mod">
          <ac:chgData name="Hamed Hooshangnejad" userId="1d4484e6-d156-41e7-adc6-6060c7474042" providerId="ADAL" clId="{4A086E61-927A-47D1-8E25-811AB0B3FED6}" dt="2021-10-15T20:17:16.359" v="179" actId="14100"/>
          <ac:spMkLst>
            <pc:docMk/>
            <pc:sldMk cId="2181576464" sldId="256"/>
            <ac:spMk id="60" creationId="{287666ED-7E52-4FBC-90B6-CFC3EA1985FD}"/>
          </ac:spMkLst>
        </pc:spChg>
        <pc:spChg chg="add mod">
          <ac:chgData name="Hamed Hooshangnejad" userId="1d4484e6-d156-41e7-adc6-6060c7474042" providerId="ADAL" clId="{4A086E61-927A-47D1-8E25-811AB0B3FED6}" dt="2021-10-15T20:17:39.978" v="238" actId="20577"/>
          <ac:spMkLst>
            <pc:docMk/>
            <pc:sldMk cId="2181576464" sldId="256"/>
            <ac:spMk id="62" creationId="{9B32A8CB-E4A2-4CCB-ADD5-7C78C6BC2B4F}"/>
          </ac:spMkLst>
        </pc:spChg>
        <pc:grpChg chg="add del mod">
          <ac:chgData name="Hamed Hooshangnejad" userId="1d4484e6-d156-41e7-adc6-6060c7474042" providerId="ADAL" clId="{4A086E61-927A-47D1-8E25-811AB0B3FED6}" dt="2021-10-15T20:05:40.204" v="7"/>
          <ac:grpSpMkLst>
            <pc:docMk/>
            <pc:sldMk cId="2181576464" sldId="256"/>
            <ac:grpSpMk id="28" creationId="{BE40DA55-B6C4-4AAB-9785-E9B680062F56}"/>
          </ac:grpSpMkLst>
        </pc:grpChg>
        <pc:grpChg chg="add del mod">
          <ac:chgData name="Hamed Hooshangnejad" userId="1d4484e6-d156-41e7-adc6-6060c7474042" providerId="ADAL" clId="{4A086E61-927A-47D1-8E25-811AB0B3FED6}" dt="2021-10-15T20:05:40.204" v="7"/>
          <ac:grpSpMkLst>
            <pc:docMk/>
            <pc:sldMk cId="2181576464" sldId="256"/>
            <ac:grpSpMk id="33" creationId="{0AD2D8B5-958C-4D2E-815B-2B4382772397}"/>
          </ac:grpSpMkLst>
        </pc:grpChg>
        <pc:grpChg chg="mod">
          <ac:chgData name="Hamed Hooshangnejad" userId="1d4484e6-d156-41e7-adc6-6060c7474042" providerId="ADAL" clId="{4A086E61-927A-47D1-8E25-811AB0B3FED6}" dt="2021-10-15T20:05:25.434" v="2"/>
          <ac:grpSpMkLst>
            <pc:docMk/>
            <pc:sldMk cId="2181576464" sldId="256"/>
            <ac:grpSpMk id="34" creationId="{BEF2702D-970D-40B4-8462-943AD76EC5FE}"/>
          </ac:grpSpMkLst>
        </pc:grpChg>
        <pc:picChg chg="add del mod">
          <ac:chgData name="Hamed Hooshangnejad" userId="1d4484e6-d156-41e7-adc6-6060c7474042" providerId="ADAL" clId="{4A086E61-927A-47D1-8E25-811AB0B3FED6}" dt="2021-10-15T20:05:40.204" v="7"/>
          <ac:picMkLst>
            <pc:docMk/>
            <pc:sldMk cId="2181576464" sldId="256"/>
            <ac:picMk id="5" creationId="{9A9AA7A5-7351-4BE5-8AA8-2F5E671A4486}"/>
          </ac:picMkLst>
        </pc:picChg>
        <pc:picChg chg="add del mod">
          <ac:chgData name="Hamed Hooshangnejad" userId="1d4484e6-d156-41e7-adc6-6060c7474042" providerId="ADAL" clId="{4A086E61-927A-47D1-8E25-811AB0B3FED6}" dt="2021-10-15T20:05:40.204" v="7"/>
          <ac:picMkLst>
            <pc:docMk/>
            <pc:sldMk cId="2181576464" sldId="256"/>
            <ac:picMk id="25" creationId="{0217C461-BBCC-4694-8C05-3EDD2A164072}"/>
          </ac:picMkLst>
        </pc:picChg>
        <pc:picChg chg="add del mod">
          <ac:chgData name="Hamed Hooshangnejad" userId="1d4484e6-d156-41e7-adc6-6060c7474042" providerId="ADAL" clId="{4A086E61-927A-47D1-8E25-811AB0B3FED6}" dt="2021-10-15T20:05:40.204" v="7"/>
          <ac:picMkLst>
            <pc:docMk/>
            <pc:sldMk cId="2181576464" sldId="256"/>
            <ac:picMk id="41" creationId="{1E152AAC-E68A-4D39-9CD1-C88B7E16798A}"/>
          </ac:picMkLst>
        </pc:picChg>
        <pc:picChg chg="add del mod">
          <ac:chgData name="Hamed Hooshangnejad" userId="1d4484e6-d156-41e7-adc6-6060c7474042" providerId="ADAL" clId="{4A086E61-927A-47D1-8E25-811AB0B3FED6}" dt="2021-10-15T20:05:40.204" v="7"/>
          <ac:picMkLst>
            <pc:docMk/>
            <pc:sldMk cId="2181576464" sldId="256"/>
            <ac:picMk id="49" creationId="{DBA5694C-FEC6-4387-8B31-B62A487C6653}"/>
          </ac:picMkLst>
        </pc:picChg>
        <pc:picChg chg="add mod">
          <ac:chgData name="Hamed Hooshangnejad" userId="1d4484e6-d156-41e7-adc6-6060c7474042" providerId="ADAL" clId="{4A086E61-927A-47D1-8E25-811AB0B3FED6}" dt="2021-10-15T20:09:14.812" v="127" actId="1037"/>
          <ac:picMkLst>
            <pc:docMk/>
            <pc:sldMk cId="2181576464" sldId="256"/>
            <ac:picMk id="53" creationId="{A6894C74-1CCA-46F2-ADB2-BB2E9274CABE}"/>
          </ac:picMkLst>
        </pc:picChg>
        <pc:picChg chg="add del mod">
          <ac:chgData name="Hamed Hooshangnejad" userId="1d4484e6-d156-41e7-adc6-6060c7474042" providerId="ADAL" clId="{4A086E61-927A-47D1-8E25-811AB0B3FED6}" dt="2021-10-15T20:15:59.882" v="131" actId="478"/>
          <ac:picMkLst>
            <pc:docMk/>
            <pc:sldMk cId="2181576464" sldId="256"/>
            <ac:picMk id="57" creationId="{1EA59B0B-9744-4E44-92D2-3F0EEAFA16EE}"/>
          </ac:picMkLst>
        </pc:picChg>
        <pc:picChg chg="add mod">
          <ac:chgData name="Hamed Hooshangnejad" userId="1d4484e6-d156-41e7-adc6-6060c7474042" providerId="ADAL" clId="{4A086E61-927A-47D1-8E25-811AB0B3FED6}" dt="2021-10-15T20:16:12.350" v="137" actId="1076"/>
          <ac:picMkLst>
            <pc:docMk/>
            <pc:sldMk cId="2181576464" sldId="256"/>
            <ac:picMk id="59" creationId="{FCD02423-51EC-49F3-9ABC-D6D158A107EB}"/>
          </ac:picMkLst>
        </pc:picChg>
        <pc:picChg chg="add mod">
          <ac:chgData name="Hamed Hooshangnejad" userId="1d4484e6-d156-41e7-adc6-6060c7474042" providerId="ADAL" clId="{4A086E61-927A-47D1-8E25-811AB0B3FED6}" dt="2021-10-15T20:34:53.832" v="251" actId="1076"/>
          <ac:picMkLst>
            <pc:docMk/>
            <pc:sldMk cId="2181576464" sldId="256"/>
            <ac:picMk id="64" creationId="{3E2C0C48-422C-46D9-8B91-A5EC43FC0D62}"/>
          </ac:picMkLst>
        </pc:pic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9" creationId="{776140F1-D96C-48E3-AB4A-F1B1531FEA8C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14" creationId="{7F2A657C-8557-4174-8C0B-E810446D4A39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17" creationId="{E3DCD758-77EB-4103-8258-2A906BC6490A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19" creationId="{C3D3D25D-38B0-406D-9CEE-F2125A54FE59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20" creationId="{47EF646A-95D8-42B6-A499-13F8DA94758A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22" creationId="{40D80E8A-EF0E-4033-8842-BD3B7A5A2762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24" creationId="{B0C0EBB5-C354-4D65-B9DA-3F17BD871E67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26" creationId="{536752D1-695F-4E3E-8FAD-D4690F92BE66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32" creationId="{68608E40-D311-4BAC-B3E0-9CB7E80E6A1A}"/>
          </ac:cxnSpMkLst>
        </pc:cxnChg>
        <pc:cxnChg chg="mod">
          <ac:chgData name="Hamed Hooshangnejad" userId="1d4484e6-d156-41e7-adc6-6060c7474042" providerId="ADAL" clId="{4A086E61-927A-47D1-8E25-811AB0B3FED6}" dt="2021-10-15T20:05:25.434" v="2"/>
          <ac:cxnSpMkLst>
            <pc:docMk/>
            <pc:sldMk cId="2181576464" sldId="256"/>
            <ac:cxnSpMk id="38" creationId="{4779A5D1-9743-4F87-B9C1-8F4A56DDF9E2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42" creationId="{BF722F45-1AD0-4E60-9CE4-C8BCA21CA712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45" creationId="{D38DDCEC-CF7E-40BF-97CB-CFDBB1B9246F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46" creationId="{12F4F266-C745-41C3-9DA3-1A9C1FA03C61}"/>
          </ac:cxnSpMkLst>
        </pc:cxnChg>
        <pc:cxnChg chg="add del mod">
          <ac:chgData name="Hamed Hooshangnejad" userId="1d4484e6-d156-41e7-adc6-6060c7474042" providerId="ADAL" clId="{4A086E61-927A-47D1-8E25-811AB0B3FED6}" dt="2021-10-15T20:05:40.204" v="7"/>
          <ac:cxnSpMkLst>
            <pc:docMk/>
            <pc:sldMk cId="2181576464" sldId="256"/>
            <ac:cxnSpMk id="51" creationId="{EF5D8D5C-2693-4E6D-8CC5-42FD5FBB46ED}"/>
          </ac:cxnSpMkLst>
        </pc:cxnChg>
      </pc:sldChg>
      <pc:sldChg chg="addSp modSp new del modAnim">
        <pc:chgData name="Hamed Hooshangnejad" userId="1d4484e6-d156-41e7-adc6-6060c7474042" providerId="ADAL" clId="{4A086E61-927A-47D1-8E25-811AB0B3FED6}" dt="2021-10-15T20:28:20.212" v="249" actId="47"/>
        <pc:sldMkLst>
          <pc:docMk/>
          <pc:sldMk cId="973100062" sldId="257"/>
        </pc:sldMkLst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4" creationId="{DCEB2C65-551F-46BF-827E-07640ED492AC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6" creationId="{66FAC362-B7B5-45DC-95B3-9D6186101A1D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7" creationId="{AF3C426A-CD6E-47B1-841A-1BB86B7DC928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8" creationId="{EA2619E9-7CB0-4C85-8705-FA007DEEE905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10" creationId="{617B6FEF-2B52-4519-971E-88F0AF08C964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11" creationId="{42AA3CAA-AED7-4B09-8C3A-A567F3B089D7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12" creationId="{BF0B9CCC-2E48-4A2C-BF42-9C58A5236333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13" creationId="{4C05BF21-5D95-49EA-A0E3-0E3FB720E938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15" creationId="{FD9DF186-C039-450D-809F-779500B707C2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16" creationId="{6FB5D54F-0BF0-4367-9778-33B6D16FE30A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18" creationId="{267994B4-9A8C-4B89-8F20-6B29D335FD95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21" creationId="{739E3885-56DB-41E5-8415-E04180FD5951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23" creationId="{56261FA5-A50E-43B9-8CAD-25EDFA8E5988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27" creationId="{5044249E-07F3-46E7-97B9-56465E3D59A0}"/>
          </ac:spMkLst>
        </pc:spChg>
        <pc:spChg chg="mod">
          <ac:chgData name="Hamed Hooshangnejad" userId="1d4484e6-d156-41e7-adc6-6060c7474042" providerId="ADAL" clId="{4A086E61-927A-47D1-8E25-811AB0B3FED6}" dt="2021-10-15T20:05:43.730" v="9"/>
          <ac:spMkLst>
            <pc:docMk/>
            <pc:sldMk cId="973100062" sldId="257"/>
            <ac:spMk id="29" creationId="{A36680E0-636E-4DF6-9115-D81CF0AB0D37}"/>
          </ac:spMkLst>
        </pc:spChg>
        <pc:spChg chg="mod">
          <ac:chgData name="Hamed Hooshangnejad" userId="1d4484e6-d156-41e7-adc6-6060c7474042" providerId="ADAL" clId="{4A086E61-927A-47D1-8E25-811AB0B3FED6}" dt="2021-10-15T20:05:43.730" v="9"/>
          <ac:spMkLst>
            <pc:docMk/>
            <pc:sldMk cId="973100062" sldId="257"/>
            <ac:spMk id="30" creationId="{40B964F3-665F-4DD7-A628-27E6E5C01F41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31" creationId="{152C0437-A38B-4452-BB07-37AC42521ACC}"/>
          </ac:spMkLst>
        </pc:spChg>
        <pc:spChg chg="mod">
          <ac:chgData name="Hamed Hooshangnejad" userId="1d4484e6-d156-41e7-adc6-6060c7474042" providerId="ADAL" clId="{4A086E61-927A-47D1-8E25-811AB0B3FED6}" dt="2021-10-15T20:05:43.730" v="9"/>
          <ac:spMkLst>
            <pc:docMk/>
            <pc:sldMk cId="973100062" sldId="257"/>
            <ac:spMk id="35" creationId="{13808204-3C10-4BA7-AC9E-F9C830B1B1E6}"/>
          </ac:spMkLst>
        </pc:spChg>
        <pc:spChg chg="mod">
          <ac:chgData name="Hamed Hooshangnejad" userId="1d4484e6-d156-41e7-adc6-6060c7474042" providerId="ADAL" clId="{4A086E61-927A-47D1-8E25-811AB0B3FED6}" dt="2021-10-15T20:05:43.730" v="9"/>
          <ac:spMkLst>
            <pc:docMk/>
            <pc:sldMk cId="973100062" sldId="257"/>
            <ac:spMk id="36" creationId="{87E4355F-CAE0-4700-966F-413B9A5B2726}"/>
          </ac:spMkLst>
        </pc:spChg>
        <pc:spChg chg="mod">
          <ac:chgData name="Hamed Hooshangnejad" userId="1d4484e6-d156-41e7-adc6-6060c7474042" providerId="ADAL" clId="{4A086E61-927A-47D1-8E25-811AB0B3FED6}" dt="2021-10-15T20:05:43.730" v="9"/>
          <ac:spMkLst>
            <pc:docMk/>
            <pc:sldMk cId="973100062" sldId="257"/>
            <ac:spMk id="37" creationId="{079E2607-BAED-4146-B54B-A16533380A39}"/>
          </ac:spMkLst>
        </pc:spChg>
        <pc:spChg chg="mod">
          <ac:chgData name="Hamed Hooshangnejad" userId="1d4484e6-d156-41e7-adc6-6060c7474042" providerId="ADAL" clId="{4A086E61-927A-47D1-8E25-811AB0B3FED6}" dt="2021-10-15T20:05:43.730" v="9"/>
          <ac:spMkLst>
            <pc:docMk/>
            <pc:sldMk cId="973100062" sldId="257"/>
            <ac:spMk id="39" creationId="{31791D9C-0A82-495B-BE98-6E48004604AF}"/>
          </ac:spMkLst>
        </pc:spChg>
        <pc:spChg chg="mod">
          <ac:chgData name="Hamed Hooshangnejad" userId="1d4484e6-d156-41e7-adc6-6060c7474042" providerId="ADAL" clId="{4A086E61-927A-47D1-8E25-811AB0B3FED6}" dt="2021-10-15T20:05:43.730" v="9"/>
          <ac:spMkLst>
            <pc:docMk/>
            <pc:sldMk cId="973100062" sldId="257"/>
            <ac:spMk id="40" creationId="{D2EDE00B-6156-424D-8F87-AE1408BDFD60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43" creationId="{C1D93242-B40B-4D3C-A830-8B06C3B8180E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44" creationId="{BE3AB683-A30A-4486-BBB6-03CB2FA7F544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47" creationId="{5C544B41-BB9D-4765-A578-FA0219D3A267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48" creationId="{B5DF4FC7-1267-4B30-95E2-85555FF0149F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50" creationId="{B76B4C6C-5795-4161-B87B-79BD2E61CC84}"/>
          </ac:spMkLst>
        </pc:spChg>
        <pc:spChg chg="add mod">
          <ac:chgData name="Hamed Hooshangnejad" userId="1d4484e6-d156-41e7-adc6-6060c7474042" providerId="ADAL" clId="{4A086E61-927A-47D1-8E25-811AB0B3FED6}" dt="2021-10-15T20:05:48.210" v="10" actId="164"/>
          <ac:spMkLst>
            <pc:docMk/>
            <pc:sldMk cId="973100062" sldId="257"/>
            <ac:spMk id="52" creationId="{69B155C4-318F-41B7-829C-A098BAFC5494}"/>
          </ac:spMkLst>
        </pc:spChg>
        <pc:grpChg chg="add mod">
          <ac:chgData name="Hamed Hooshangnejad" userId="1d4484e6-d156-41e7-adc6-6060c7474042" providerId="ADAL" clId="{4A086E61-927A-47D1-8E25-811AB0B3FED6}" dt="2021-10-15T20:05:48.210" v="10" actId="164"/>
          <ac:grpSpMkLst>
            <pc:docMk/>
            <pc:sldMk cId="973100062" sldId="257"/>
            <ac:grpSpMk id="28" creationId="{A0C2C4A3-B19B-4296-9E4B-89CDCC29ACD2}"/>
          </ac:grpSpMkLst>
        </pc:grpChg>
        <pc:grpChg chg="add mod">
          <ac:chgData name="Hamed Hooshangnejad" userId="1d4484e6-d156-41e7-adc6-6060c7474042" providerId="ADAL" clId="{4A086E61-927A-47D1-8E25-811AB0B3FED6}" dt="2021-10-15T20:05:48.210" v="10" actId="164"/>
          <ac:grpSpMkLst>
            <pc:docMk/>
            <pc:sldMk cId="973100062" sldId="257"/>
            <ac:grpSpMk id="33" creationId="{D715C9EA-C9C5-4336-A37B-E54A21049E16}"/>
          </ac:grpSpMkLst>
        </pc:grpChg>
        <pc:grpChg chg="mod">
          <ac:chgData name="Hamed Hooshangnejad" userId="1d4484e6-d156-41e7-adc6-6060c7474042" providerId="ADAL" clId="{4A086E61-927A-47D1-8E25-811AB0B3FED6}" dt="2021-10-15T20:05:43.730" v="9"/>
          <ac:grpSpMkLst>
            <pc:docMk/>
            <pc:sldMk cId="973100062" sldId="257"/>
            <ac:grpSpMk id="34" creationId="{BB059428-AFF8-4D5C-A9B1-937796C3B6A4}"/>
          </ac:grpSpMkLst>
        </pc:grpChg>
        <pc:grpChg chg="add mod">
          <ac:chgData name="Hamed Hooshangnejad" userId="1d4484e6-d156-41e7-adc6-6060c7474042" providerId="ADAL" clId="{4A086E61-927A-47D1-8E25-811AB0B3FED6}" dt="2021-10-15T20:05:48.210" v="10" actId="164"/>
          <ac:grpSpMkLst>
            <pc:docMk/>
            <pc:sldMk cId="973100062" sldId="257"/>
            <ac:grpSpMk id="53" creationId="{3470F8E5-AEB6-463A-A2C2-DBDA0DDDA9ED}"/>
          </ac:grpSpMkLst>
        </pc:grpChg>
        <pc:picChg chg="add mod">
          <ac:chgData name="Hamed Hooshangnejad" userId="1d4484e6-d156-41e7-adc6-6060c7474042" providerId="ADAL" clId="{4A086E61-927A-47D1-8E25-811AB0B3FED6}" dt="2021-10-15T20:05:48.210" v="10" actId="164"/>
          <ac:picMkLst>
            <pc:docMk/>
            <pc:sldMk cId="973100062" sldId="257"/>
            <ac:picMk id="5" creationId="{52A3651F-EE35-437D-BF34-88C0713E4CFD}"/>
          </ac:picMkLst>
        </pc:picChg>
        <pc:picChg chg="add mod">
          <ac:chgData name="Hamed Hooshangnejad" userId="1d4484e6-d156-41e7-adc6-6060c7474042" providerId="ADAL" clId="{4A086E61-927A-47D1-8E25-811AB0B3FED6}" dt="2021-10-15T20:05:48.210" v="10" actId="164"/>
          <ac:picMkLst>
            <pc:docMk/>
            <pc:sldMk cId="973100062" sldId="257"/>
            <ac:picMk id="25" creationId="{65BC6653-591F-492E-A9AB-5BC78741E1BD}"/>
          </ac:picMkLst>
        </pc:picChg>
        <pc:picChg chg="add mod">
          <ac:chgData name="Hamed Hooshangnejad" userId="1d4484e6-d156-41e7-adc6-6060c7474042" providerId="ADAL" clId="{4A086E61-927A-47D1-8E25-811AB0B3FED6}" dt="2021-10-15T20:05:48.210" v="10" actId="164"/>
          <ac:picMkLst>
            <pc:docMk/>
            <pc:sldMk cId="973100062" sldId="257"/>
            <ac:picMk id="41" creationId="{62949560-2BF7-4E13-847B-A7FFA34521F1}"/>
          </ac:picMkLst>
        </pc:picChg>
        <pc:picChg chg="add mod">
          <ac:chgData name="Hamed Hooshangnejad" userId="1d4484e6-d156-41e7-adc6-6060c7474042" providerId="ADAL" clId="{4A086E61-927A-47D1-8E25-811AB0B3FED6}" dt="2021-10-15T20:05:48.210" v="10" actId="164"/>
          <ac:picMkLst>
            <pc:docMk/>
            <pc:sldMk cId="973100062" sldId="257"/>
            <ac:picMk id="49" creationId="{29A47114-8667-4E5F-A647-01A192C482D4}"/>
          </ac:picMkLst>
        </pc:pic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9" creationId="{51518970-C4FE-4AAA-9E93-DDCFA53A7232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14" creationId="{44256D37-5EEC-4052-AC3C-6F36C98A0149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17" creationId="{5A6A0394-B832-4249-8933-EF9C0994ACDF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19" creationId="{DA0035C3-FA86-41B2-83FD-9FC7D12366A8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20" creationId="{D7CB6B28-070F-4990-99A5-711703CA41F5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22" creationId="{ABDE81A2-FFB1-4D6F-A4F0-41508F2C829B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24" creationId="{CEC4ACB8-DF4E-4D88-8F5F-D8B81C899A1F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26" creationId="{322B8B59-C46A-4F93-968A-F71FF8212C38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32" creationId="{FAB4986A-8A61-4D98-8EA5-E04D7D605432}"/>
          </ac:cxnSpMkLst>
        </pc:cxnChg>
        <pc:cxnChg chg="mod">
          <ac:chgData name="Hamed Hooshangnejad" userId="1d4484e6-d156-41e7-adc6-6060c7474042" providerId="ADAL" clId="{4A086E61-927A-47D1-8E25-811AB0B3FED6}" dt="2021-10-15T20:05:43.730" v="9"/>
          <ac:cxnSpMkLst>
            <pc:docMk/>
            <pc:sldMk cId="973100062" sldId="257"/>
            <ac:cxnSpMk id="38" creationId="{AC1C4B18-EDA7-4CF3-B444-FF1254641F1D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42" creationId="{EF00859E-BAFC-4531-942E-A999946DFC25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45" creationId="{5D4FE0BE-F712-4934-9435-A7C4878AF17C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46" creationId="{06F9442C-FF9A-4625-8909-E711842727F5}"/>
          </ac:cxnSpMkLst>
        </pc:cxnChg>
        <pc:cxnChg chg="add mod">
          <ac:chgData name="Hamed Hooshangnejad" userId="1d4484e6-d156-41e7-adc6-6060c7474042" providerId="ADAL" clId="{4A086E61-927A-47D1-8E25-811AB0B3FED6}" dt="2021-10-15T20:05:48.210" v="10" actId="164"/>
          <ac:cxnSpMkLst>
            <pc:docMk/>
            <pc:sldMk cId="973100062" sldId="257"/>
            <ac:cxnSpMk id="51" creationId="{31FDDC10-2621-4D1B-A486-6C46B1420304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1047539"/>
            <a:ext cx="10287000" cy="2228427"/>
          </a:xfrm>
        </p:spPr>
        <p:txBody>
          <a:bodyPr anchor="b"/>
          <a:lstStyle>
            <a:lvl1pPr algn="ctr">
              <a:defRPr sz="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3361902"/>
            <a:ext cx="10287000" cy="1545378"/>
          </a:xfrm>
        </p:spPr>
        <p:txBody>
          <a:bodyPr/>
          <a:lstStyle>
            <a:lvl1pPr marL="0" indent="0" algn="ctr">
              <a:buNone/>
              <a:defRPr sz="2240"/>
            </a:lvl1pPr>
            <a:lvl2pPr marL="426705" indent="0" algn="ctr">
              <a:buNone/>
              <a:defRPr sz="1867"/>
            </a:lvl2pPr>
            <a:lvl3pPr marL="853410" indent="0" algn="ctr">
              <a:buNone/>
              <a:defRPr sz="1680"/>
            </a:lvl3pPr>
            <a:lvl4pPr marL="1280114" indent="0" algn="ctr">
              <a:buNone/>
              <a:defRPr sz="1493"/>
            </a:lvl4pPr>
            <a:lvl5pPr marL="1706819" indent="0" algn="ctr">
              <a:buNone/>
              <a:defRPr sz="1493"/>
            </a:lvl5pPr>
            <a:lvl6pPr marL="2133524" indent="0" algn="ctr">
              <a:buNone/>
              <a:defRPr sz="1493"/>
            </a:lvl6pPr>
            <a:lvl7pPr marL="2560229" indent="0" algn="ctr">
              <a:buNone/>
              <a:defRPr sz="1493"/>
            </a:lvl7pPr>
            <a:lvl8pPr marL="2986933" indent="0" algn="ctr">
              <a:buNone/>
              <a:defRPr sz="1493"/>
            </a:lvl8pPr>
            <a:lvl9pPr marL="3413638" indent="0" algn="ctr">
              <a:buNone/>
              <a:defRPr sz="149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793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4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2" y="340783"/>
            <a:ext cx="2957513" cy="54243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5" y="340783"/>
            <a:ext cx="8701088" cy="54243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715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517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1" y="1595756"/>
            <a:ext cx="11830050" cy="2662555"/>
          </a:xfrm>
        </p:spPr>
        <p:txBody>
          <a:bodyPr anchor="b"/>
          <a:lstStyle>
            <a:lvl1pPr>
              <a:defRPr sz="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1" y="4283499"/>
            <a:ext cx="11830050" cy="1400175"/>
          </a:xfrm>
        </p:spPr>
        <p:txBody>
          <a:bodyPr/>
          <a:lstStyle>
            <a:lvl1pPr marL="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1pPr>
            <a:lvl2pPr marL="426705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2pPr>
            <a:lvl3pPr marL="85341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3pPr>
            <a:lvl4pPr marL="1280114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4pPr>
            <a:lvl5pPr marL="1706819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5pPr>
            <a:lvl6pPr marL="2133524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6pPr>
            <a:lvl7pPr marL="2560229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7pPr>
            <a:lvl8pPr marL="2986933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8pPr>
            <a:lvl9pPr marL="3413638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596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1703917"/>
            <a:ext cx="5829300" cy="40612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1703917"/>
            <a:ext cx="5829300" cy="40612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308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340784"/>
            <a:ext cx="11830050" cy="123719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2" y="1569085"/>
            <a:ext cx="5802510" cy="768985"/>
          </a:xfrm>
        </p:spPr>
        <p:txBody>
          <a:bodyPr anchor="b"/>
          <a:lstStyle>
            <a:lvl1pPr marL="0" indent="0">
              <a:buNone/>
              <a:defRPr sz="2240" b="1"/>
            </a:lvl1pPr>
            <a:lvl2pPr marL="426705" indent="0">
              <a:buNone/>
              <a:defRPr sz="1867" b="1"/>
            </a:lvl2pPr>
            <a:lvl3pPr marL="853410" indent="0">
              <a:buNone/>
              <a:defRPr sz="1680" b="1"/>
            </a:lvl3pPr>
            <a:lvl4pPr marL="1280114" indent="0">
              <a:buNone/>
              <a:defRPr sz="1493" b="1"/>
            </a:lvl4pPr>
            <a:lvl5pPr marL="1706819" indent="0">
              <a:buNone/>
              <a:defRPr sz="1493" b="1"/>
            </a:lvl5pPr>
            <a:lvl6pPr marL="2133524" indent="0">
              <a:buNone/>
              <a:defRPr sz="1493" b="1"/>
            </a:lvl6pPr>
            <a:lvl7pPr marL="2560229" indent="0">
              <a:buNone/>
              <a:defRPr sz="1493" b="1"/>
            </a:lvl7pPr>
            <a:lvl8pPr marL="2986933" indent="0">
              <a:buNone/>
              <a:defRPr sz="1493" b="1"/>
            </a:lvl8pPr>
            <a:lvl9pPr marL="3413638" indent="0">
              <a:buNone/>
              <a:defRPr sz="149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2" y="2338070"/>
            <a:ext cx="5802510" cy="34389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5" y="1569085"/>
            <a:ext cx="5831087" cy="768985"/>
          </a:xfrm>
        </p:spPr>
        <p:txBody>
          <a:bodyPr anchor="b"/>
          <a:lstStyle>
            <a:lvl1pPr marL="0" indent="0">
              <a:buNone/>
              <a:defRPr sz="2240" b="1"/>
            </a:lvl1pPr>
            <a:lvl2pPr marL="426705" indent="0">
              <a:buNone/>
              <a:defRPr sz="1867" b="1"/>
            </a:lvl2pPr>
            <a:lvl3pPr marL="853410" indent="0">
              <a:buNone/>
              <a:defRPr sz="1680" b="1"/>
            </a:lvl3pPr>
            <a:lvl4pPr marL="1280114" indent="0">
              <a:buNone/>
              <a:defRPr sz="1493" b="1"/>
            </a:lvl4pPr>
            <a:lvl5pPr marL="1706819" indent="0">
              <a:buNone/>
              <a:defRPr sz="1493" b="1"/>
            </a:lvl5pPr>
            <a:lvl6pPr marL="2133524" indent="0">
              <a:buNone/>
              <a:defRPr sz="1493" b="1"/>
            </a:lvl6pPr>
            <a:lvl7pPr marL="2560229" indent="0">
              <a:buNone/>
              <a:defRPr sz="1493" b="1"/>
            </a:lvl7pPr>
            <a:lvl8pPr marL="2986933" indent="0">
              <a:buNone/>
              <a:defRPr sz="1493" b="1"/>
            </a:lvl8pPr>
            <a:lvl9pPr marL="3413638" indent="0">
              <a:buNone/>
              <a:defRPr sz="149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5" y="2338070"/>
            <a:ext cx="5831087" cy="34389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383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02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566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26720"/>
            <a:ext cx="4423767" cy="1493520"/>
          </a:xfrm>
        </p:spPr>
        <p:txBody>
          <a:bodyPr anchor="b"/>
          <a:lstStyle>
            <a:lvl1pPr>
              <a:defRPr sz="29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921597"/>
            <a:ext cx="6943725" cy="4548717"/>
          </a:xfrm>
        </p:spPr>
        <p:txBody>
          <a:bodyPr/>
          <a:lstStyle>
            <a:lvl1pPr>
              <a:defRPr sz="2987"/>
            </a:lvl1pPr>
            <a:lvl2pPr>
              <a:defRPr sz="2613"/>
            </a:lvl2pPr>
            <a:lvl3pPr>
              <a:defRPr sz="2240"/>
            </a:lvl3pPr>
            <a:lvl4pPr>
              <a:defRPr sz="1867"/>
            </a:lvl4pPr>
            <a:lvl5pPr>
              <a:defRPr sz="1867"/>
            </a:lvl5pPr>
            <a:lvl6pPr>
              <a:defRPr sz="1867"/>
            </a:lvl6pPr>
            <a:lvl7pPr>
              <a:defRPr sz="1867"/>
            </a:lvl7pPr>
            <a:lvl8pPr>
              <a:defRPr sz="1867"/>
            </a:lvl8pPr>
            <a:lvl9pPr>
              <a:defRPr sz="18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1920240"/>
            <a:ext cx="4423767" cy="3557482"/>
          </a:xfrm>
        </p:spPr>
        <p:txBody>
          <a:bodyPr/>
          <a:lstStyle>
            <a:lvl1pPr marL="0" indent="0">
              <a:buNone/>
              <a:defRPr sz="1493"/>
            </a:lvl1pPr>
            <a:lvl2pPr marL="426705" indent="0">
              <a:buNone/>
              <a:defRPr sz="1307"/>
            </a:lvl2pPr>
            <a:lvl3pPr marL="853410" indent="0">
              <a:buNone/>
              <a:defRPr sz="1120"/>
            </a:lvl3pPr>
            <a:lvl4pPr marL="1280114" indent="0">
              <a:buNone/>
              <a:defRPr sz="933"/>
            </a:lvl4pPr>
            <a:lvl5pPr marL="1706819" indent="0">
              <a:buNone/>
              <a:defRPr sz="933"/>
            </a:lvl5pPr>
            <a:lvl6pPr marL="2133524" indent="0">
              <a:buNone/>
              <a:defRPr sz="933"/>
            </a:lvl6pPr>
            <a:lvl7pPr marL="2560229" indent="0">
              <a:buNone/>
              <a:defRPr sz="933"/>
            </a:lvl7pPr>
            <a:lvl8pPr marL="2986933" indent="0">
              <a:buNone/>
              <a:defRPr sz="933"/>
            </a:lvl8pPr>
            <a:lvl9pPr marL="3413638" indent="0">
              <a:buNone/>
              <a:defRPr sz="9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070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26720"/>
            <a:ext cx="4423767" cy="1493520"/>
          </a:xfrm>
        </p:spPr>
        <p:txBody>
          <a:bodyPr anchor="b"/>
          <a:lstStyle>
            <a:lvl1pPr>
              <a:defRPr sz="29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921597"/>
            <a:ext cx="6943725" cy="4548717"/>
          </a:xfrm>
        </p:spPr>
        <p:txBody>
          <a:bodyPr anchor="t"/>
          <a:lstStyle>
            <a:lvl1pPr marL="0" indent="0">
              <a:buNone/>
              <a:defRPr sz="2987"/>
            </a:lvl1pPr>
            <a:lvl2pPr marL="426705" indent="0">
              <a:buNone/>
              <a:defRPr sz="2613"/>
            </a:lvl2pPr>
            <a:lvl3pPr marL="853410" indent="0">
              <a:buNone/>
              <a:defRPr sz="2240"/>
            </a:lvl3pPr>
            <a:lvl4pPr marL="1280114" indent="0">
              <a:buNone/>
              <a:defRPr sz="1867"/>
            </a:lvl4pPr>
            <a:lvl5pPr marL="1706819" indent="0">
              <a:buNone/>
              <a:defRPr sz="1867"/>
            </a:lvl5pPr>
            <a:lvl6pPr marL="2133524" indent="0">
              <a:buNone/>
              <a:defRPr sz="1867"/>
            </a:lvl6pPr>
            <a:lvl7pPr marL="2560229" indent="0">
              <a:buNone/>
              <a:defRPr sz="1867"/>
            </a:lvl7pPr>
            <a:lvl8pPr marL="2986933" indent="0">
              <a:buNone/>
              <a:defRPr sz="1867"/>
            </a:lvl8pPr>
            <a:lvl9pPr marL="3413638" indent="0">
              <a:buNone/>
              <a:defRPr sz="18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1920240"/>
            <a:ext cx="4423767" cy="3557482"/>
          </a:xfrm>
        </p:spPr>
        <p:txBody>
          <a:bodyPr/>
          <a:lstStyle>
            <a:lvl1pPr marL="0" indent="0">
              <a:buNone/>
              <a:defRPr sz="1493"/>
            </a:lvl1pPr>
            <a:lvl2pPr marL="426705" indent="0">
              <a:buNone/>
              <a:defRPr sz="1307"/>
            </a:lvl2pPr>
            <a:lvl3pPr marL="853410" indent="0">
              <a:buNone/>
              <a:defRPr sz="1120"/>
            </a:lvl3pPr>
            <a:lvl4pPr marL="1280114" indent="0">
              <a:buNone/>
              <a:defRPr sz="933"/>
            </a:lvl4pPr>
            <a:lvl5pPr marL="1706819" indent="0">
              <a:buNone/>
              <a:defRPr sz="933"/>
            </a:lvl5pPr>
            <a:lvl6pPr marL="2133524" indent="0">
              <a:buNone/>
              <a:defRPr sz="933"/>
            </a:lvl6pPr>
            <a:lvl7pPr marL="2560229" indent="0">
              <a:buNone/>
              <a:defRPr sz="933"/>
            </a:lvl7pPr>
            <a:lvl8pPr marL="2986933" indent="0">
              <a:buNone/>
              <a:defRPr sz="933"/>
            </a:lvl8pPr>
            <a:lvl9pPr marL="3413638" indent="0">
              <a:buNone/>
              <a:defRPr sz="9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698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340784"/>
            <a:ext cx="11830050" cy="12371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1703917"/>
            <a:ext cx="11830050" cy="40612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5932594"/>
            <a:ext cx="308610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2D907-0999-4F19-B6AD-EBCE3D4B1F97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5932594"/>
            <a:ext cx="462915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5932594"/>
            <a:ext cx="308610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FBFE8-E723-4375-9F08-78CB8724A3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429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53410" rtl="0" eaLnBrk="1" latinLnBrk="0" hangingPunct="1">
        <a:lnSpc>
          <a:spcPct val="90000"/>
        </a:lnSpc>
        <a:spcBef>
          <a:spcPct val="0"/>
        </a:spcBef>
        <a:buNone/>
        <a:defRPr sz="41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3352" indent="-213352" algn="l" defTabSz="8534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2613" kern="1200">
          <a:solidFill>
            <a:schemeClr val="tx1"/>
          </a:solidFill>
          <a:latin typeface="+mn-lt"/>
          <a:ea typeface="+mn-ea"/>
          <a:cs typeface="+mn-cs"/>
        </a:defRPr>
      </a:lvl1pPr>
      <a:lvl2pPr marL="640057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2pPr>
      <a:lvl3pPr marL="1066762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3pPr>
      <a:lvl4pPr marL="1493467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4pPr>
      <a:lvl5pPr marL="1920171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5pPr>
      <a:lvl6pPr marL="2346876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6pPr>
      <a:lvl7pPr marL="2773581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86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8pPr>
      <a:lvl9pPr marL="3626990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26705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53410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14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4pPr>
      <a:lvl5pPr marL="1706819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5pPr>
      <a:lvl6pPr marL="2133524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6pPr>
      <a:lvl7pPr marL="2560229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7pPr>
      <a:lvl8pPr marL="2986933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8pPr>
      <a:lvl9pPr marL="3413638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52">
            <a:extLst>
              <a:ext uri="{FF2B5EF4-FFF2-40B4-BE49-F238E27FC236}">
                <a16:creationId xmlns:a16="http://schemas.microsoft.com/office/drawing/2014/main" id="{A6894C74-1CCA-46F2-ADB2-BB2E9274CA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2487" y="1467067"/>
            <a:ext cx="7610758" cy="3718069"/>
          </a:xfrm>
          <a:prstGeom prst="rect">
            <a:avLst/>
          </a:prstGeom>
        </p:spPr>
      </p:pic>
      <p:sp>
        <p:nvSpPr>
          <p:cNvPr id="54" name="Rectangle: Rounded Corners 53">
            <a:extLst>
              <a:ext uri="{FF2B5EF4-FFF2-40B4-BE49-F238E27FC236}">
                <a16:creationId xmlns:a16="http://schemas.microsoft.com/office/drawing/2014/main" id="{34CE3F19-A4B5-41ED-9592-33C42EC42791}"/>
              </a:ext>
            </a:extLst>
          </p:cNvPr>
          <p:cNvSpPr/>
          <p:nvPr/>
        </p:nvSpPr>
        <p:spPr>
          <a:xfrm>
            <a:off x="139152" y="994394"/>
            <a:ext cx="7734093" cy="4457282"/>
          </a:xfrm>
          <a:prstGeom prst="roundRect">
            <a:avLst/>
          </a:prstGeom>
          <a:noFill/>
          <a:ln w="38100" cap="rnd"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D7A2111-C171-4795-AAE4-B2C5FF3EF224}"/>
              </a:ext>
            </a:extLst>
          </p:cNvPr>
          <p:cNvSpPr txBox="1"/>
          <p:nvPr/>
        </p:nvSpPr>
        <p:spPr>
          <a:xfrm>
            <a:off x="532929" y="625062"/>
            <a:ext cx="7069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Validation of Virtual Spacer Simulation Platform</a:t>
            </a:r>
          </a:p>
        </p:txBody>
      </p:sp>
      <p:pic>
        <p:nvPicPr>
          <p:cNvPr id="59" name="Picture 58" descr="A picture containing spectacles&#10;&#10;Description automatically generated">
            <a:extLst>
              <a:ext uri="{FF2B5EF4-FFF2-40B4-BE49-F238E27FC236}">
                <a16:creationId xmlns:a16="http://schemas.microsoft.com/office/drawing/2014/main" id="{FCD02423-51EC-49F3-9ABC-D6D158A107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6580" y="1277382"/>
            <a:ext cx="1925382" cy="4097438"/>
          </a:xfrm>
          <a:prstGeom prst="rect">
            <a:avLst/>
          </a:prstGeom>
        </p:spPr>
      </p:pic>
      <p:sp>
        <p:nvSpPr>
          <p:cNvPr id="60" name="Rectangle: Rounded Corners 59">
            <a:extLst>
              <a:ext uri="{FF2B5EF4-FFF2-40B4-BE49-F238E27FC236}">
                <a16:creationId xmlns:a16="http://schemas.microsoft.com/office/drawing/2014/main" id="{287666ED-7E52-4FBC-90B6-CFC3EA1985FD}"/>
              </a:ext>
            </a:extLst>
          </p:cNvPr>
          <p:cNvSpPr/>
          <p:nvPr/>
        </p:nvSpPr>
        <p:spPr>
          <a:xfrm>
            <a:off x="7988439" y="1025980"/>
            <a:ext cx="5465074" cy="4457282"/>
          </a:xfrm>
          <a:prstGeom prst="roundRect">
            <a:avLst/>
          </a:prstGeom>
          <a:noFill/>
          <a:ln w="38100" cap="rnd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B32A8CB-E4A2-4CCB-ADD5-7C78C6BC2B4F}"/>
              </a:ext>
            </a:extLst>
          </p:cNvPr>
          <p:cNvSpPr txBox="1"/>
          <p:nvPr/>
        </p:nvSpPr>
        <p:spPr>
          <a:xfrm>
            <a:off x="7291976" y="625062"/>
            <a:ext cx="6858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ystematic Simulation Duodenal Spacer</a:t>
            </a: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3E2C0C48-422C-46D9-8B91-A5EC43FC0D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483030" y="1129173"/>
            <a:ext cx="2198863" cy="4187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1576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2D870BA882F1E4B87BA25D9F8E0879A" ma:contentTypeVersion="13" ma:contentTypeDescription="Create a new document." ma:contentTypeScope="" ma:versionID="42aeadbccf10f410497c3220cae30d96">
  <xsd:schema xmlns:xsd="http://www.w3.org/2001/XMLSchema" xmlns:xs="http://www.w3.org/2001/XMLSchema" xmlns:p="http://schemas.microsoft.com/office/2006/metadata/properties" xmlns:ns2="80e1c943-ef7d-4a32-97ee-f7079cf55c34" xmlns:ns3="21efe994-e207-4f59-966d-ea2410a476de" targetNamespace="http://schemas.microsoft.com/office/2006/metadata/properties" ma:root="true" ma:fieldsID="3b75474f9f911074a831e5b69d17bc11" ns2:_="" ns3:_="">
    <xsd:import namespace="80e1c943-ef7d-4a32-97ee-f7079cf55c34"/>
    <xsd:import namespace="21efe994-e207-4f59-966d-ea2410a476d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3:SharedWithUsers" minOccurs="0"/>
                <xsd:element ref="ns3:SharedWithDetails" minOccurs="0"/>
                <xsd:element ref="ns2:MediaLengthInSecond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e1c943-ef7d-4a32-97ee-f7079cf55c3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1efe994-e207-4f59-966d-ea2410a476d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40625D8-9B16-4FA1-B842-04AAC9E2B5A1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0E1EC950-82BA-4966-A4EC-1F8F0B6C64D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D89DA37-B3B0-4655-A391-AC7A86A0962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0e1c943-ef7d-4a32-97ee-f7079cf55c34"/>
    <ds:schemaRef ds:uri="21efe994-e207-4f59-966d-ea2410a476d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10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ed Hooshangnejad</dc:creator>
  <cp:lastModifiedBy>Hamed Hooshangnejad</cp:lastModifiedBy>
  <cp:revision>1</cp:revision>
  <dcterms:created xsi:type="dcterms:W3CDTF">2021-10-15T19:41:52Z</dcterms:created>
  <dcterms:modified xsi:type="dcterms:W3CDTF">2021-12-10T21:30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2D870BA882F1E4B87BA25D9F8E0879A</vt:lpwstr>
  </property>
</Properties>
</file>